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9"/>
    <p:restoredTop sz="94787"/>
  </p:normalViewPr>
  <p:slideViewPr>
    <p:cSldViewPr snapToGrid="0" snapToObjects="1">
      <p:cViewPr varScale="1">
        <p:scale>
          <a:sx n="99" d="100"/>
          <a:sy n="99" d="100"/>
        </p:scale>
        <p:origin x="9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FFD05-FAA5-1943-8428-1EF94075D1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D7D701-0448-4348-8711-972130A6F65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B5D1AC-78F8-6442-A8CE-6CA630EFD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49FA5-F085-BC43-BDB0-1D004E246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BF5D5A-71D7-174A-8BD6-459D4177DA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827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2F495C-CAB8-9848-BF35-44461F15BF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B1CE3B0-5F3B-D647-8376-701DD1A85B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18712A-5899-F643-9178-BBE7C7ED89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C9431F-2748-C74B-A29E-C6DFE6B02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A064AC-B573-414F-A6AD-734AD105DF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3126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EB5E68-F8FD-E74F-BFBA-1588E64AA1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18A0BDB-F719-1341-966B-AC8C14A072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B92491-7A18-0249-B0F5-718234313A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295805-9BC0-9B4A-BFBA-F5CDC7C1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5896D3-4CD2-7246-BDC6-08507FCFAC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8303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CD17CA-A7E0-2A47-AAD3-40FF82C8EB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0AEAF3-D956-6B4F-9BDD-D469C1BE8E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3809F-26A3-B946-9C5A-5962A8607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74C6CD-A5FA-C944-AA06-B5ECC5F4D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9DAB6-CA51-9344-8225-2C6F78742A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8870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CFEB1B-6621-174B-B82A-780BB1BACB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F3AAFF-F39A-EB42-A345-7CF8F40C75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A6828A-917D-E74A-A246-CC4F8F3116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F3B0DA-5EC4-3C4E-844D-2DE69160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8BA7B79-A8A2-0941-A4B0-4CFAD40E3B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11420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B64F4-5140-4C48-BD08-43AF35D5A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073DEC-8511-6D4C-9EEA-CAFE55008A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688D35-D4BE-B843-912A-23A7652563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9859BE-1EF2-4E4A-A976-4F2D4244C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634A53D-75FE-C145-AB92-E3F36975A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1E6EBA-8800-1F48-82A0-1DE1EFA594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631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AF2DC0-CD9C-5B41-A5F3-A1BCF38E6B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D5A92B-5BB9-DF45-B847-08FE206004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FC5F4AE-2A59-E24B-9215-DE5BD6762E1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4F62C3-2889-0E4C-B66D-A5443F4800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2337366-1758-DF4B-898E-67C56A6FF6F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DD3A113-EBC3-C247-B17A-22E993B34A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02C9E0-7979-B647-8E97-4FB061DBD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E1D7221-69E0-614A-AE6B-F5EFC45F37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1714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257A79-8C30-D84E-B544-02BC22E255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8119880-6F65-C941-9DAF-168069AC7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71D4314-D45D-1F49-A26C-669E0D547E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5E69203-E6BA-F844-8469-F400BA742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7522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4C89BBF-EAAC-B94E-B24D-180A1EF9BA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27A5907-B314-2D46-82DF-F5B187D450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A9DB05-8073-7F43-9BFA-95255A883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4232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EE20D1-C8EA-3E4C-95B6-4C2E68EE0D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56E280A-83DE-F342-83EE-18002F17F7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60596ED-01C7-0F40-A997-D3B7F44939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9834E7-C020-4341-B081-2C3050D3A1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D9C6F6-7A1E-2A40-9B6F-57B3B4FB0F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D4C0CA-C375-4744-9510-540A0C07A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1962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6209FF-859F-3F41-B49E-75C8C559BA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40EEC45-1730-A041-BEAB-048D46F4B43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874D9F-8BC3-3C4E-9B6B-DFAAB965A2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549B28-8884-CB4B-B3B8-2C4C32F9F4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153E05-6F4C-724D-BD27-6B1E95718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5B808B-618A-3E4C-A83F-AE87E7B6D1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36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D3F2AB9-8B7B-714D-A6AC-50B00B61C3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62B39-B354-4146-828B-E2F96D9A22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250B85-5094-3B4F-B60A-022FBA19E15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765C8-153D-B24E-8FA2-99EB96D845A2}" type="datetimeFigureOut">
              <a:rPr lang="en-US" smtClean="0"/>
              <a:t>10/2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41A761-0D01-9A4B-920A-A7DBD6B0A7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4B397F-AA17-4A45-959C-E9D1D98C03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142376-1225-4449-9250-103316A184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95662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91A7E99-6F70-4F4E-8755-1C5BE989066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9300" y="1718643"/>
            <a:ext cx="9988369" cy="5029773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4D2FB566-94B5-F74B-8CB1-BB3E5C27BF18}"/>
              </a:ext>
            </a:extLst>
          </p:cNvPr>
          <p:cNvSpPr txBox="1"/>
          <p:nvPr/>
        </p:nvSpPr>
        <p:spPr>
          <a:xfrm>
            <a:off x="0" y="109584"/>
            <a:ext cx="9880718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S3: </a:t>
            </a:r>
          </a:p>
          <a:p>
            <a:r>
              <a:rPr lang="en-US" dirty="0"/>
              <a:t>The fractions of GRP78 peptides with phosphorylation modifications from various rGRP78 preparation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61099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6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an Nguyen, Thi Kim</dc:creator>
  <cp:lastModifiedBy>Tran Nguyen, Thi Kim</cp:lastModifiedBy>
  <cp:revision>4</cp:revision>
  <cp:lastPrinted>2020-10-02T21:50:05Z</cp:lastPrinted>
  <dcterms:created xsi:type="dcterms:W3CDTF">2018-08-22T19:49:34Z</dcterms:created>
  <dcterms:modified xsi:type="dcterms:W3CDTF">2020-10-02T21:50:09Z</dcterms:modified>
</cp:coreProperties>
</file>